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94CEA7-1A0C-41FA-BE6C-30ADC759BD9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45D9B5-7A69-4518-B3E4-92DBDC2CD2B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04B4BE-5800-4FFA-AEAF-3964E2F503B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CEACF7-8043-47E8-A73E-67B2D0314DF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1D8A58-19AA-42FA-9318-DB1BCAE1B29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639292-CCFF-444D-99F0-DC0F32D948D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207777-596B-435A-BA70-F02B1ED24A5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D12E23-F085-46F4-9EDF-C9F9BE113F5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DB31BE-DA99-49D8-818B-2063D7F635D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B1BA9E-5AAE-4BA0-AE40-F94D3B01632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A4E392-67E5-4B52-8F14-155BB19637E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5669DA-4470-4FA5-BD43-858BC49B25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s-E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279A4184-FFB8-4CF0-890E-763431D631FC}" type="slidenum">
              <a:rPr b="0" lang="es-E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523880" y="1047600"/>
          <a:ext cx="6096240" cy="1300320"/>
        </p:xfrm>
        <a:graphic>
          <a:graphicData uri="http://schemas.openxmlformats.org/drawingml/2006/table">
            <a:tbl>
              <a:tblPr/>
              <a:tblGrid>
                <a:gridCol w="3206880"/>
                <a:gridCol w="2889360"/>
              </a:tblGrid>
              <a:tr h="4572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GB" sz="1200" spc="-1" strike="noStrike">
                          <a:solidFill>
                            <a:srgbClr val="ffffff"/>
                          </a:solidFill>
                          <a:latin typeface="Arial"/>
                          <a:ea typeface="Arial"/>
                        </a:rPr>
                        <a:t>Genotyp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GB" sz="1200" spc="-1" strike="noStrike">
                          <a:solidFill>
                            <a:srgbClr val="ffffff"/>
                          </a:solidFill>
                          <a:latin typeface="Arial"/>
                          <a:ea typeface="Arial"/>
                        </a:rPr>
                        <a:t>% Survival* (Observed individuals/Expected individuals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</a:tr>
              <a:tr h="3700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es-E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p/Cyo; p52</a:t>
                      </a:r>
                      <a:r>
                        <a:rPr b="0" i="1" lang="es-ES" sz="12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P3605/mrn</a:t>
                      </a:r>
                      <a:r>
                        <a:rPr b="0" i="1" lang="es-ES" sz="1200" spc="-1" strike="noStrike" baseline="5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7%  (263/462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4730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YFP-p52/EYFP-p52; p52</a:t>
                      </a:r>
                      <a:r>
                        <a:rPr b="0" i="1" lang="en-US" sz="12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P3605</a:t>
                      </a: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/p52</a:t>
                      </a:r>
                      <a:r>
                        <a:rPr b="0" i="1" lang="en-US" sz="12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rn</a:t>
                      </a:r>
                      <a:r>
                        <a:rPr b="0" i="1" lang="en-US" sz="1200" spc="-1" strike="noStrike" baseline="5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0% (468/468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42" name=""/>
          <p:cNvGraphicFramePr/>
          <p:nvPr/>
        </p:nvGraphicFramePr>
        <p:xfrm>
          <a:off x="1523880" y="4130640"/>
          <a:ext cx="6096240" cy="1273320"/>
        </p:xfrm>
        <a:graphic>
          <a:graphicData uri="http://schemas.openxmlformats.org/drawingml/2006/table">
            <a:tbl>
              <a:tblPr/>
              <a:tblGrid>
                <a:gridCol w="2649600"/>
                <a:gridCol w="3446640"/>
              </a:tblGrid>
              <a:tr h="63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s-ES" sz="1200" spc="-1" strike="noStrike">
                          <a:solidFill>
                            <a:srgbClr val="ffffff"/>
                          </a:solidFill>
                          <a:latin typeface="Arial"/>
                          <a:ea typeface="Arial"/>
                        </a:rPr>
                        <a:t>Genotyp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GB" sz="1200" spc="-1" strike="noStrike">
                          <a:solidFill>
                            <a:srgbClr val="ffffff"/>
                          </a:solidFill>
                          <a:latin typeface="Arial"/>
                          <a:ea typeface="Arial"/>
                        </a:rPr>
                        <a:t>% Survival* (Observed Individuals/Expected individuals 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</a:tr>
              <a:tr h="3175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8</a:t>
                      </a:r>
                      <a:r>
                        <a:rPr b="0" i="1" lang="en-US" sz="12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/p8</a:t>
                      </a:r>
                      <a:r>
                        <a:rPr b="0" i="1" lang="en-US" sz="12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; TM2/MKR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6% (102/387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3193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8</a:t>
                      </a:r>
                      <a:r>
                        <a:rPr b="0" i="1" lang="en-US" sz="12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/p8</a:t>
                      </a:r>
                      <a:r>
                        <a:rPr b="0" i="1" lang="en-US" sz="12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; p8-ECFP/p8-ECFP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8% (108/186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  <p:sp>
        <p:nvSpPr>
          <p:cNvPr id="43" name="CuadroTexto 9"/>
          <p:cNvSpPr/>
          <p:nvPr/>
        </p:nvSpPr>
        <p:spPr>
          <a:xfrm>
            <a:off x="1568880" y="560520"/>
            <a:ext cx="5167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Table S1. Rescue of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p52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heteroallelic mutant by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the EYFP-p52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transgen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CuadroTexto 10"/>
          <p:cNvSpPr/>
          <p:nvPr/>
        </p:nvSpPr>
        <p:spPr>
          <a:xfrm>
            <a:off x="1657440" y="3713040"/>
            <a:ext cx="4511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Table S2. Rescue of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p8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null mutant by the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p8-ECFP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transgene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CuadroTexto 11"/>
          <p:cNvSpPr/>
          <p:nvPr/>
        </p:nvSpPr>
        <p:spPr>
          <a:xfrm>
            <a:off x="1543320" y="2424240"/>
            <a:ext cx="597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* Number of organisms that develop until adults. Only the relevant classes are shown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CuadroTexto 12"/>
          <p:cNvSpPr/>
          <p:nvPr/>
        </p:nvSpPr>
        <p:spPr>
          <a:xfrm>
            <a:off x="1702080" y="5429160"/>
            <a:ext cx="59367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*Number of organisms that develop until adults. Only the relevant classes are shown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ll the rescued organisms are fertile and do not show any obvious defects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2-27T22:39:24Z</dcterms:created>
  <dc:creator>MARIO ZURITA</dc:creator>
  <dc:description/>
  <dc:language>en-US</dc:language>
  <cp:lastModifiedBy>GC</cp:lastModifiedBy>
  <dcterms:modified xsi:type="dcterms:W3CDTF">2016-09-10T08:33:00Z</dcterms:modified>
  <cp:revision>23</cp:revision>
  <dc:subject/>
  <dc:title>Presentación de PowerPoint</dc:title>
</cp:coreProperties>
</file>